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notesSlides/notesSlide18.xml" ContentType="application/vnd.openxmlformats-officedocument.presentationml.notesSlide+xml"/>
  <Default Extension="rels" ContentType="application/vnd.openxmlformats-package.relationships+xml"/>
  <Default Extension="xml" ContentType="application/xml"/>
  <Override PartName="/ppt/slides/slide14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notesSlides/notesSlide16.xml" ContentType="application/vnd.openxmlformats-officedocument.presentationml.notesSlide+xml"/>
  <Override PartName="/ppt/slides/slide10.xml" ContentType="application/vnd.openxmlformats-officedocument.presentationml.slide+xml"/>
  <Override PartName="/ppt/slides/slide12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notesSlides/notesSlide14.xml" ContentType="application/vnd.openxmlformats-officedocument.presentationml.notesSlide+xml"/>
  <Override PartName="/ppt/notesSlides/notesSlide23.xml" ContentType="application/vnd.openxmlformats-officedocument.presentationml.notesSlide+xml"/>
  <Override PartName="/ppt/slideLayouts/slideLayout10.xml" ContentType="application/vnd.openxmlformats-officedocument.presentationml.slideLayout+xml"/>
  <Default Extension="tiff" ContentType="image/tiff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9.xml" ContentType="application/vnd.openxmlformats-officedocument.presentationml.notes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24.xml" ContentType="application/vnd.openxmlformats-officedocument.presentationml.slide+xml"/>
  <Override PartName="/ppt/slideLayouts/slideLayout3.xml" ContentType="application/vnd.openxmlformats-officedocument.presentationml.slideLayout+xml"/>
  <Default Extension="jpeg" ContentType="image/jpeg"/>
  <Override PartName="/ppt/notesSlides/notesSlide17.xml" ContentType="application/vnd.openxmlformats-officedocument.presentationml.notesSlide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22.xml" ContentType="application/vnd.openxmlformats-officedocument.presentationml.slide+xml"/>
  <Override PartName="/ppt/slideLayouts/slideLayout1.xml" ContentType="application/vnd.openxmlformats-officedocument.presentationml.slideLayout+xml"/>
  <Override PartName="/ppt/notesSlides/notesSlide15.xml" ContentType="application/vnd.openxmlformats-officedocument.presentationml.notesSlide+xml"/>
  <Override PartName="/ppt/notesSlides/notesSlide24.xml" ContentType="application/vnd.openxmlformats-officedocument.presentationml.notesSlide+xml"/>
  <Override PartName="/docProps/app.xml" ContentType="application/vnd.openxmlformats-officedocument.extended-properties+xml"/>
  <Override PartName="/ppt/slides/slide11.xml" ContentType="application/vnd.openxmlformats-officedocument.presentationml.slide+xml"/>
  <Override PartName="/ppt/slides/slide20.xml" ContentType="application/vnd.openxmlformats-officedocument.presentationml.slide+xml"/>
  <Override PartName="/ppt/notesSlides/notesSlide13.xml" ContentType="application/vnd.openxmlformats-officedocument.presentationml.notesSlide+xml"/>
  <Override PartName="/ppt/notesSlides/notesSlide22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6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74" r:id="rId13"/>
    <p:sldId id="275" r:id="rId14"/>
    <p:sldId id="276" r:id="rId15"/>
    <p:sldId id="277" r:id="rId16"/>
    <p:sldId id="278" r:id="rId17"/>
    <p:sldId id="267" r:id="rId18"/>
    <p:sldId id="268" r:id="rId19"/>
    <p:sldId id="269" r:id="rId20"/>
    <p:sldId id="270" r:id="rId21"/>
    <p:sldId id="271" r:id="rId22"/>
    <p:sldId id="272" r:id="rId23"/>
    <p:sldId id="273" r:id="rId24"/>
    <p:sldId id="279" r:id="rId2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26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6585D6-BA0B-43BD-8C5D-1ABEE4EF907A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183D09-DEDF-4C05-B33F-220827039711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0</a:t>
            </a:fld>
            <a:endParaRPr lang="en-GB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1</a:t>
            </a:fld>
            <a:endParaRPr lang="en-GB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2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2</a:t>
            </a:fld>
            <a:endParaRPr lang="en-GB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</a:t>
            </a:r>
            <a:r>
              <a:rPr lang="en-GB" baseline="0" dirty="0" smtClean="0"/>
              <a:t> 1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3</a:t>
            </a:fld>
            <a:endParaRPr lang="en-GB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4</a:t>
            </a:fld>
            <a:endParaRPr lang="en-GB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5</a:t>
            </a:fld>
            <a:endParaRPr lang="en-GB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6</a:t>
            </a:fld>
            <a:endParaRPr lang="en-GB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7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7</a:t>
            </a:fld>
            <a:endParaRPr lang="en-GB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8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8</a:t>
            </a:fld>
            <a:endParaRPr lang="en-GB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1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19</a:t>
            </a:fld>
            <a:endParaRPr lang="en-GB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2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2</a:t>
            </a:fld>
            <a:endParaRPr lang="en-GB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</a:t>
            </a:r>
            <a:r>
              <a:rPr lang="en-GB" baseline="0" dirty="0" smtClean="0"/>
              <a:t> 20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20</a:t>
            </a:fld>
            <a:endParaRPr lang="en-GB"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warthog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21</a:t>
            </a:fld>
            <a:endParaRPr lang="en-GB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Zebra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22</a:t>
            </a:fld>
            <a:endParaRPr lang="en-GB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Giraffe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23</a:t>
            </a:fld>
            <a:endParaRPr lang="en-GB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smtClean="0"/>
              <a:t>Rhino</a:t>
            </a:r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24</a:t>
            </a:fld>
            <a:endParaRPr lang="en-GB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3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3</a:t>
            </a:fld>
            <a:endParaRPr lang="en-GB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4</a:t>
            </a:fld>
            <a:endParaRPr lang="en-GB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5</a:t>
            </a:fld>
            <a:endParaRPr lang="en-GB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6</a:t>
            </a:fld>
            <a:endParaRPr lang="en-GB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7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7</a:t>
            </a:fld>
            <a:endParaRPr lang="en-GB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8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8</a:t>
            </a:fld>
            <a:endParaRPr lang="en-GB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Sample 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83D09-DEDF-4C05-B33F-220827039711}" type="slidenum">
              <a:rPr lang="en-GB" smtClean="0"/>
              <a:pPr/>
              <a:t>9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9DB44-1249-41A5-B136-44CFFA760174}" type="datetimeFigureOut">
              <a:rPr lang="en-GB" smtClean="0"/>
              <a:pPr/>
              <a:t>20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AC716-5E11-48B8-8DF3-B4578ABEC86D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3 copy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1310431" y="0"/>
            <a:ext cx="6523137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 rot="16200000">
            <a:off x="1714466" y="-986275"/>
            <a:ext cx="5738433" cy="8520309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4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 rot="16200000">
            <a:off x="1063407" y="-151602"/>
            <a:ext cx="6533223" cy="72929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3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544403"/>
            <a:ext cx="9144000" cy="5769194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1348740" y="0"/>
            <a:ext cx="644652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8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683223" y="0"/>
            <a:ext cx="7777554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4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 rot="16200000">
            <a:off x="925860" y="-470141"/>
            <a:ext cx="6572199" cy="7776864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4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538456"/>
            <a:ext cx="9144000" cy="5781087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357740" y="0"/>
            <a:ext cx="8428519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3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1226510"/>
            <a:ext cx="9144000" cy="440498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 rot="5400000">
            <a:off x="1582305" y="-1135642"/>
            <a:ext cx="5879096" cy="8885268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 copy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5579" y="0"/>
            <a:ext cx="9132841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400373" y="0"/>
            <a:ext cx="8343254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5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617791"/>
            <a:ext cx="9144000" cy="5622417"/>
          </a:xfrm>
          <a:prstGeom prst="rect">
            <a:avLst/>
          </a:prstGeom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Zebra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329618" y="0"/>
            <a:ext cx="8484763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 copy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1675920"/>
            <a:ext cx="9144000" cy="3506159"/>
          </a:xfrm>
          <a:prstGeom prst="rect">
            <a:avLst/>
          </a:prstGeom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3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617791"/>
            <a:ext cx="9144000" cy="5622417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3.tif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617791"/>
            <a:ext cx="9144000" cy="5622417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5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 rot="16200000">
            <a:off x="940367" y="-800241"/>
            <a:ext cx="6708746" cy="8374471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4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1020535" y="0"/>
            <a:ext cx="7102929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3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0" y="1116849"/>
            <a:ext cx="9144000" cy="4624302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6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1377904" y="0"/>
            <a:ext cx="6388192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7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928741" y="0"/>
            <a:ext cx="7286517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.jpg"/>
          <p:cNvPicPr>
            <a:picLocks noChangeAspect="1"/>
          </p:cNvPicPr>
          <p:nvPr/>
        </p:nvPicPr>
        <p:blipFill>
          <a:blip r:embed="rId3" cstate="email"/>
          <a:stretch>
            <a:fillRect/>
          </a:stretch>
        </p:blipFill>
        <p:spPr>
          <a:xfrm>
            <a:off x="780395" y="0"/>
            <a:ext cx="7583210" cy="6858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8</Words>
  <Application>Microsoft Office PowerPoint</Application>
  <PresentationFormat>On-screen Show (4:3)</PresentationFormat>
  <Paragraphs>48</Paragraphs>
  <Slides>24</Slides>
  <Notes>2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5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ditor</dc:creator>
  <cp:lastModifiedBy>Editor</cp:lastModifiedBy>
  <cp:revision>3</cp:revision>
  <dcterms:created xsi:type="dcterms:W3CDTF">2018-09-12T17:53:32Z</dcterms:created>
  <dcterms:modified xsi:type="dcterms:W3CDTF">2018-11-20T07:58:06Z</dcterms:modified>
</cp:coreProperties>
</file>